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736" autoAdjust="0"/>
  </p:normalViewPr>
  <p:slideViewPr>
    <p:cSldViewPr>
      <p:cViewPr>
        <p:scale>
          <a:sx n="100" d="100"/>
          <a:sy n="100" d="100"/>
        </p:scale>
        <p:origin x="-2892" y="3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1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/>
          <a:lstStyle>
            <a:lvl1pPr algn="r">
              <a:defRPr sz="1300"/>
            </a:lvl1pPr>
          </a:lstStyle>
          <a:p>
            <a:fld id="{AFF549EC-2D11-46A6-B0A7-ED0A85A81DEC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6125"/>
            <a:ext cx="2574925" cy="37226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71" tIns="47786" rIns="95571" bIns="47786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5571" tIns="47786" rIns="95571" bIns="47786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33107"/>
            <a:ext cx="2944283" cy="496570"/>
          </a:xfrm>
          <a:prstGeom prst="rect">
            <a:avLst/>
          </a:prstGeom>
        </p:spPr>
        <p:txBody>
          <a:bodyPr vert="horz" lIns="95571" tIns="47786" rIns="95571" bIns="47786" rtlCol="0" anchor="b"/>
          <a:lstStyle>
            <a:lvl1pPr algn="r">
              <a:defRPr sz="1300"/>
            </a:lvl1pPr>
          </a:lstStyle>
          <a:p>
            <a:fld id="{5D710603-2D3E-4786-9A44-2160958960B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006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710603-2D3E-4786-9A44-2160958960B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5438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963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333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10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574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271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94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064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68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062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702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833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23AE5-465D-46A8-B432-C10BE695986F}" type="datetimeFigureOut">
              <a:rPr lang="en-US" smtClean="0"/>
              <a:t>8/11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584F4-AB60-4D4F-92D0-70FD816B36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899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80728" y="473738"/>
            <a:ext cx="48965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able 1: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r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1124744" y="7329264"/>
            <a:ext cx="417646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=sign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fertile, b=sign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ININ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c=sign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INF, d=sig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SW; *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&lt;0.05, **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&lt;0.01, ***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245178"/>
              </p:ext>
            </p:extLst>
          </p:nvPr>
        </p:nvGraphicFramePr>
        <p:xfrm>
          <a:off x="1124744" y="791938"/>
          <a:ext cx="4165354" cy="653732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1428366"/>
                <a:gridCol w="684247"/>
                <a:gridCol w="684247"/>
                <a:gridCol w="684247"/>
                <a:gridCol w="684247"/>
              </a:tblGrid>
              <a:tr h="17973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u="none" strike="noStrike" dirty="0">
                          <a:effectLst/>
                        </a:rPr>
                        <a:t> </a:t>
                      </a:r>
                      <a:r>
                        <a:rPr lang="en-US" sz="1000" b="1" u="none" strike="noStrike" dirty="0" smtClean="0">
                          <a:effectLst/>
                        </a:rPr>
                        <a:t>Taxo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900" b="1" u="none" strike="noStrike" smtClean="0">
                          <a:effectLst/>
                        </a:rPr>
                        <a:t>Fertile [%]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900" b="1" u="none" strike="noStrike" dirty="0" err="1" smtClean="0">
                          <a:effectLst/>
                        </a:rPr>
                        <a:t>nININF</a:t>
                      </a:r>
                      <a:r>
                        <a:rPr lang="en-US" sz="900" b="1" u="none" strike="noStrike" dirty="0" smtClean="0">
                          <a:effectLst/>
                        </a:rPr>
                        <a:t> [%]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900" b="1" u="none" strike="noStrike" smtClean="0">
                          <a:effectLst/>
                        </a:rPr>
                        <a:t>ININF [%]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900" b="1" u="none" strike="noStrike" smtClean="0">
                          <a:effectLst/>
                        </a:rPr>
                        <a:t>FSW [%]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>
                          <a:effectLst/>
                        </a:rPr>
                        <a:t>Lactobacillus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69.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57.7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a**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78.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41.7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Gardnerell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c*,d**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a*,d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,b*,c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5.4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5.6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0.0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0.7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Prevotell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3.93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7.3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a*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3.0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3.8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Sneathi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5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,b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5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50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7.1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Atopobium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7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1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6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3.9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Lachnospiraceae</a:t>
                      </a:r>
                      <a:r>
                        <a:rPr lang="en-US" sz="1000" b="1" u="none" strike="noStrike" dirty="0">
                          <a:effectLst/>
                        </a:rPr>
                        <a:t>, BVAB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b**,c*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>
                          <a:effectLst/>
                        </a:rPr>
                        <a:t>a**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19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0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6.59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69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>
                          <a:effectLst/>
                        </a:rPr>
                        <a:t>Streptococcus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7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6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5.50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23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</a:rPr>
                        <a:t> 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Dialister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59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9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2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3.0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Bifidobacterium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4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2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1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7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Veillonell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7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63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5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2.4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091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Enterobacteriaceae</a:t>
                      </a:r>
                      <a:r>
                        <a:rPr lang="en-US" sz="1000" b="1" u="none" strike="noStrike" dirty="0">
                          <a:effectLst/>
                        </a:rPr>
                        <a:t>, unclassifie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70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9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2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2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Aerococcus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b*,d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4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7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49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3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>
                          <a:effectLst/>
                        </a:rPr>
                        <a:t>Mycoplasm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7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,b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70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>
                          <a:effectLst/>
                        </a:rPr>
                        <a:t>Neisseri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8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Porphyromonas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2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2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0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Granulicatella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5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4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1179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Clostridiales</a:t>
                      </a:r>
                      <a:r>
                        <a:rPr lang="en-US" sz="1000" b="1" u="none" strike="noStrike" dirty="0">
                          <a:effectLst/>
                        </a:rPr>
                        <a:t>, unclassifie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a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3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6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>
                          <a:effectLst/>
                        </a:rPr>
                        <a:t>d***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97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12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1.0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77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1" u="none" strike="noStrike" dirty="0" err="1">
                          <a:effectLst/>
                        </a:rPr>
                        <a:t>Corynebacterium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 w="12700" cmpd="sng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7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smtClean="0">
                          <a:effectLst/>
                        </a:rPr>
                        <a:t>1.28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US" sz="1000" u="none" strike="noStrike" dirty="0" smtClean="0">
                          <a:effectLst/>
                        </a:rPr>
                        <a:t>0.05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559" marR="8559" marT="8559" marB="0" anchor="b">
                    <a:lnL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18317790"/>
      </p:ext>
    </p:extLst>
  </p:cSld>
  <p:clrMapOvr>
    <a:masterClrMapping/>
  </p:clrMapOvr>
</p:sld>
</file>

<file path=ppt/theme/theme1.xml><?xml version="1.0" encoding="utf-8"?>
<a:theme xmlns:a="http://schemas.openxmlformats.org/drawingml/2006/main" name="Graspeuntner et al_suppl. figures_SG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Graspeuntner et al_suppl. figures_SG</Template>
  <TotalTime>0</TotalTime>
  <Words>217</Words>
  <Application>Microsoft Office PowerPoint</Application>
  <PresentationFormat>A4-Papier (210x297 mm)</PresentationFormat>
  <Paragraphs>129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Graspeuntner et al_suppl. figures_SG</vt:lpstr>
      <vt:lpstr>PowerPoint-Präsentation</vt:lpstr>
    </vt:vector>
  </TitlesOfParts>
  <Company>ITS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Bi, AGRupp</dc:creator>
  <cp:lastModifiedBy>MiBi, AGRupp</cp:lastModifiedBy>
  <cp:revision>7</cp:revision>
  <cp:lastPrinted>2016-02-13T11:55:58Z</cp:lastPrinted>
  <dcterms:created xsi:type="dcterms:W3CDTF">2016-07-21T14:01:48Z</dcterms:created>
  <dcterms:modified xsi:type="dcterms:W3CDTF">2017-08-11T12:10:02Z</dcterms:modified>
</cp:coreProperties>
</file>